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</p:sldMasterIdLst>
  <p:sldIdLst>
    <p:sldId id="265" r:id="rId2"/>
    <p:sldId id="264" r:id="rId3"/>
    <p:sldId id="260" r:id="rId4"/>
    <p:sldId id="261" r:id="rId5"/>
    <p:sldId id="262" r:id="rId6"/>
    <p:sldId id="257" r:id="rId7"/>
    <p:sldId id="258" r:id="rId8"/>
    <p:sldId id="259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7" y="4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avind Gandhi" userId="20e1d1d5cf36f95c" providerId="LiveId" clId="{80F8DC1F-0DA5-4331-8DAB-E46B6D0B748B}"/>
    <pc:docChg chg="undo custSel addSld delSld modSld sldOrd modMainMaster">
      <pc:chgData name="Aravind Gandhi" userId="20e1d1d5cf36f95c" providerId="LiveId" clId="{80F8DC1F-0DA5-4331-8DAB-E46B6D0B748B}" dt="2023-07-18T18:02:26.845" v="386"/>
      <pc:docMkLst>
        <pc:docMk/>
      </pc:docMkLst>
      <pc:sldChg chg="modSp new del">
        <pc:chgData name="Aravind Gandhi" userId="20e1d1d5cf36f95c" providerId="LiveId" clId="{80F8DC1F-0DA5-4331-8DAB-E46B6D0B748B}" dt="2023-07-18T17:56:10.781" v="382" actId="47"/>
        <pc:sldMkLst>
          <pc:docMk/>
          <pc:sldMk cId="2416213040" sldId="256"/>
        </pc:sldMkLst>
        <pc:spChg chg="mod">
          <ac:chgData name="Aravind Gandhi" userId="20e1d1d5cf36f95c" providerId="LiveId" clId="{80F8DC1F-0DA5-4331-8DAB-E46B6D0B748B}" dt="2023-07-18T17:04:25.116" v="19"/>
          <ac:spMkLst>
            <pc:docMk/>
            <pc:sldMk cId="2416213040" sldId="256"/>
            <ac:spMk id="2" creationId="{517BF53E-8407-C276-ECB9-9BE827F3F2D7}"/>
          </ac:spMkLst>
        </pc:spChg>
        <pc:spChg chg="mod">
          <ac:chgData name="Aravind Gandhi" userId="20e1d1d5cf36f95c" providerId="LiveId" clId="{80F8DC1F-0DA5-4331-8DAB-E46B6D0B748B}" dt="2023-07-18T17:04:25.116" v="19"/>
          <ac:spMkLst>
            <pc:docMk/>
            <pc:sldMk cId="2416213040" sldId="256"/>
            <ac:spMk id="3" creationId="{953E1950-2D15-2CF1-2D02-47250E27CBA0}"/>
          </ac:spMkLst>
        </pc:spChg>
      </pc:sldChg>
      <pc:sldChg chg="new del">
        <pc:chgData name="Aravind Gandhi" userId="20e1d1d5cf36f95c" providerId="LiveId" clId="{80F8DC1F-0DA5-4331-8DAB-E46B6D0B748B}" dt="2023-07-18T17:00:57.355" v="2" actId="47"/>
        <pc:sldMkLst>
          <pc:docMk/>
          <pc:sldMk cId="1019205948" sldId="257"/>
        </pc:sldMkLst>
      </pc:sldChg>
      <pc:sldChg chg="addSp modSp add mod">
        <pc:chgData name="Aravind Gandhi" userId="20e1d1d5cf36f95c" providerId="LiveId" clId="{80F8DC1F-0DA5-4331-8DAB-E46B6D0B748B}" dt="2023-07-18T17:51:55.142" v="312" actId="113"/>
        <pc:sldMkLst>
          <pc:docMk/>
          <pc:sldMk cId="3198658571" sldId="257"/>
        </pc:sldMkLst>
        <pc:spChg chg="add mod">
          <ac:chgData name="Aravind Gandhi" userId="20e1d1d5cf36f95c" providerId="LiveId" clId="{80F8DC1F-0DA5-4331-8DAB-E46B6D0B748B}" dt="2023-07-18T17:51:55.142" v="312" actId="113"/>
          <ac:spMkLst>
            <pc:docMk/>
            <pc:sldMk cId="3198658571" sldId="257"/>
            <ac:spMk id="2" creationId="{C28AD51F-EE47-881A-E293-337AFD6F17F7}"/>
          </ac:spMkLst>
        </pc:spChg>
        <pc:spChg chg="mod">
          <ac:chgData name="Aravind Gandhi" userId="20e1d1d5cf36f95c" providerId="LiveId" clId="{80F8DC1F-0DA5-4331-8DAB-E46B6D0B748B}" dt="2023-07-18T17:50:30.529" v="275" actId="1076"/>
          <ac:spMkLst>
            <pc:docMk/>
            <pc:sldMk cId="3198658571" sldId="257"/>
            <ac:spMk id="8" creationId="{7BB33867-304F-6D95-6DBB-19237542D362}"/>
          </ac:spMkLst>
        </pc:spChg>
      </pc:sldChg>
      <pc:sldChg chg="addSp delSp modSp add del mod">
        <pc:chgData name="Aravind Gandhi" userId="20e1d1d5cf36f95c" providerId="LiveId" clId="{80F8DC1F-0DA5-4331-8DAB-E46B6D0B748B}" dt="2023-07-18T17:16:09.651" v="152" actId="2696"/>
        <pc:sldMkLst>
          <pc:docMk/>
          <pc:sldMk cId="4120749027" sldId="257"/>
        </pc:sldMkLst>
        <pc:spChg chg="del">
          <ac:chgData name="Aravind Gandhi" userId="20e1d1d5cf36f95c" providerId="LiveId" clId="{80F8DC1F-0DA5-4331-8DAB-E46B6D0B748B}" dt="2023-07-18T17:01:27.493" v="5" actId="478"/>
          <ac:spMkLst>
            <pc:docMk/>
            <pc:sldMk cId="4120749027" sldId="257"/>
            <ac:spMk id="2" creationId="{517BF53E-8407-C276-ECB9-9BE827F3F2D7}"/>
          </ac:spMkLst>
        </pc:spChg>
        <pc:spChg chg="del">
          <ac:chgData name="Aravind Gandhi" userId="20e1d1d5cf36f95c" providerId="LiveId" clId="{80F8DC1F-0DA5-4331-8DAB-E46B6D0B748B}" dt="2023-07-18T17:01:25.063" v="4" actId="478"/>
          <ac:spMkLst>
            <pc:docMk/>
            <pc:sldMk cId="4120749027" sldId="257"/>
            <ac:spMk id="3" creationId="{953E1950-2D15-2CF1-2D02-47250E27CBA0}"/>
          </ac:spMkLst>
        </pc:spChg>
        <pc:spChg chg="add mod">
          <ac:chgData name="Aravind Gandhi" userId="20e1d1d5cf36f95c" providerId="LiveId" clId="{80F8DC1F-0DA5-4331-8DAB-E46B6D0B748B}" dt="2023-07-18T17:12:26.063" v="104" actId="20577"/>
          <ac:spMkLst>
            <pc:docMk/>
            <pc:sldMk cId="4120749027" sldId="257"/>
            <ac:spMk id="8" creationId="{7BB33867-304F-6D95-6DBB-19237542D362}"/>
          </ac:spMkLst>
        </pc:spChg>
        <pc:picChg chg="add del mod">
          <ac:chgData name="Aravind Gandhi" userId="20e1d1d5cf36f95c" providerId="LiveId" clId="{80F8DC1F-0DA5-4331-8DAB-E46B6D0B748B}" dt="2023-07-18T17:04:05.293" v="17"/>
          <ac:picMkLst>
            <pc:docMk/>
            <pc:sldMk cId="4120749027" sldId="257"/>
            <ac:picMk id="5" creationId="{1906E9C8-66DB-67C8-38CB-2F0AED2CD1B4}"/>
          </ac:picMkLst>
        </pc:picChg>
        <pc:picChg chg="add mod">
          <ac:chgData name="Aravind Gandhi" userId="20e1d1d5cf36f95c" providerId="LiveId" clId="{80F8DC1F-0DA5-4331-8DAB-E46B6D0B748B}" dt="2023-07-18T17:05:08.346" v="31" actId="1076"/>
          <ac:picMkLst>
            <pc:docMk/>
            <pc:sldMk cId="4120749027" sldId="257"/>
            <ac:picMk id="7" creationId="{7A40D73F-A6BE-CD4F-D9D0-30C750E78125}"/>
          </ac:picMkLst>
        </pc:picChg>
      </pc:sldChg>
      <pc:sldChg chg="addSp modSp add mod">
        <pc:chgData name="Aravind Gandhi" userId="20e1d1d5cf36f95c" providerId="LiveId" clId="{80F8DC1F-0DA5-4331-8DAB-E46B6D0B748B}" dt="2023-07-18T17:51:58.136" v="313" actId="113"/>
        <pc:sldMkLst>
          <pc:docMk/>
          <pc:sldMk cId="2930428112" sldId="258"/>
        </pc:sldMkLst>
        <pc:spChg chg="add mod">
          <ac:chgData name="Aravind Gandhi" userId="20e1d1d5cf36f95c" providerId="LiveId" clId="{80F8DC1F-0DA5-4331-8DAB-E46B6D0B748B}" dt="2023-07-18T17:51:58.136" v="313" actId="113"/>
          <ac:spMkLst>
            <pc:docMk/>
            <pc:sldMk cId="2930428112" sldId="258"/>
            <ac:spMk id="2" creationId="{FD7089EF-6EF0-6712-35AA-FBB57635D6F9}"/>
          </ac:spMkLst>
        </pc:spChg>
        <pc:spChg chg="mod">
          <ac:chgData name="Aravind Gandhi" userId="20e1d1d5cf36f95c" providerId="LiveId" clId="{80F8DC1F-0DA5-4331-8DAB-E46B6D0B748B}" dt="2023-07-18T17:50:08.617" v="262" actId="1076"/>
          <ac:spMkLst>
            <pc:docMk/>
            <pc:sldMk cId="2930428112" sldId="258"/>
            <ac:spMk id="6" creationId="{BB4E96DB-B79C-C2F1-1D05-129A038267D2}"/>
          </ac:spMkLst>
        </pc:spChg>
      </pc:sldChg>
      <pc:sldChg chg="addSp delSp modSp new del mod">
        <pc:chgData name="Aravind Gandhi" userId="20e1d1d5cf36f95c" providerId="LiveId" clId="{80F8DC1F-0DA5-4331-8DAB-E46B6D0B748B}" dt="2023-07-18T17:16:09.651" v="152" actId="2696"/>
        <pc:sldMkLst>
          <pc:docMk/>
          <pc:sldMk cId="3792205638" sldId="258"/>
        </pc:sldMkLst>
        <pc:spChg chg="del">
          <ac:chgData name="Aravind Gandhi" userId="20e1d1d5cf36f95c" providerId="LiveId" clId="{80F8DC1F-0DA5-4331-8DAB-E46B6D0B748B}" dt="2023-07-18T17:04:37.700" v="22" actId="478"/>
          <ac:spMkLst>
            <pc:docMk/>
            <pc:sldMk cId="3792205638" sldId="258"/>
            <ac:spMk id="2" creationId="{85E28114-F495-E3AD-C085-4573BF66F62C}"/>
          </ac:spMkLst>
        </pc:spChg>
        <pc:spChg chg="del">
          <ac:chgData name="Aravind Gandhi" userId="20e1d1d5cf36f95c" providerId="LiveId" clId="{80F8DC1F-0DA5-4331-8DAB-E46B6D0B748B}" dt="2023-07-18T17:04:35.680" v="21" actId="478"/>
          <ac:spMkLst>
            <pc:docMk/>
            <pc:sldMk cId="3792205638" sldId="258"/>
            <ac:spMk id="3" creationId="{5247DB8D-E06C-63A1-565C-D9C9C0EDE109}"/>
          </ac:spMkLst>
        </pc:spChg>
        <pc:spChg chg="add mod">
          <ac:chgData name="Aravind Gandhi" userId="20e1d1d5cf36f95c" providerId="LiveId" clId="{80F8DC1F-0DA5-4331-8DAB-E46B6D0B748B}" dt="2023-07-18T17:12:50.332" v="124" actId="20577"/>
          <ac:spMkLst>
            <pc:docMk/>
            <pc:sldMk cId="3792205638" sldId="258"/>
            <ac:spMk id="6" creationId="{BB4E96DB-B79C-C2F1-1D05-129A038267D2}"/>
          </ac:spMkLst>
        </pc:spChg>
        <pc:picChg chg="add mod">
          <ac:chgData name="Aravind Gandhi" userId="20e1d1d5cf36f95c" providerId="LiveId" clId="{80F8DC1F-0DA5-4331-8DAB-E46B6D0B748B}" dt="2023-07-18T17:06:36.867" v="60" actId="1076"/>
          <ac:picMkLst>
            <pc:docMk/>
            <pc:sldMk cId="3792205638" sldId="258"/>
            <ac:picMk id="5" creationId="{6C1EA82E-8E83-E4CF-40DE-66CE6D75B0B1}"/>
          </ac:picMkLst>
        </pc:picChg>
      </pc:sldChg>
      <pc:sldChg chg="addSp delSp modSp add mod">
        <pc:chgData name="Aravind Gandhi" userId="20e1d1d5cf36f95c" providerId="LiveId" clId="{80F8DC1F-0DA5-4331-8DAB-E46B6D0B748B}" dt="2023-07-18T17:52:10.803" v="318" actId="478"/>
        <pc:sldMkLst>
          <pc:docMk/>
          <pc:sldMk cId="678304573" sldId="259"/>
        </pc:sldMkLst>
        <pc:spChg chg="add del mod">
          <ac:chgData name="Aravind Gandhi" userId="20e1d1d5cf36f95c" providerId="LiveId" clId="{80F8DC1F-0DA5-4331-8DAB-E46B6D0B748B}" dt="2023-07-18T17:52:10.803" v="318" actId="478"/>
          <ac:spMkLst>
            <pc:docMk/>
            <pc:sldMk cId="678304573" sldId="259"/>
            <ac:spMk id="2" creationId="{66E0D79A-8B64-03C7-A5C2-B19D0A7D1353}"/>
          </ac:spMkLst>
        </pc:spChg>
        <pc:spChg chg="mod">
          <ac:chgData name="Aravind Gandhi" userId="20e1d1d5cf36f95c" providerId="LiveId" clId="{80F8DC1F-0DA5-4331-8DAB-E46B6D0B748B}" dt="2023-07-18T17:50:39.398" v="277" actId="1076"/>
          <ac:spMkLst>
            <pc:docMk/>
            <pc:sldMk cId="678304573" sldId="259"/>
            <ac:spMk id="4" creationId="{0EB0D4D0-889A-9014-B30B-2E655B58E30F}"/>
          </ac:spMkLst>
        </pc:spChg>
        <pc:spChg chg="add mod">
          <ac:chgData name="Aravind Gandhi" userId="20e1d1d5cf36f95c" providerId="LiveId" clId="{80F8DC1F-0DA5-4331-8DAB-E46B6D0B748B}" dt="2023-07-18T17:52:08.559" v="317" actId="20577"/>
          <ac:spMkLst>
            <pc:docMk/>
            <pc:sldMk cId="678304573" sldId="259"/>
            <ac:spMk id="5" creationId="{B024354E-6126-2E7F-77C1-C45430FC4119}"/>
          </ac:spMkLst>
        </pc:spChg>
      </pc:sldChg>
      <pc:sldChg chg="addSp modSp add del mod">
        <pc:chgData name="Aravind Gandhi" userId="20e1d1d5cf36f95c" providerId="LiveId" clId="{80F8DC1F-0DA5-4331-8DAB-E46B6D0B748B}" dt="2023-07-18T17:16:09.651" v="152" actId="2696"/>
        <pc:sldMkLst>
          <pc:docMk/>
          <pc:sldMk cId="1085601703" sldId="259"/>
        </pc:sldMkLst>
        <pc:spChg chg="add mod">
          <ac:chgData name="Aravind Gandhi" userId="20e1d1d5cf36f95c" providerId="LiveId" clId="{80F8DC1F-0DA5-4331-8DAB-E46B6D0B748B}" dt="2023-07-18T17:13:22.301" v="151" actId="20577"/>
          <ac:spMkLst>
            <pc:docMk/>
            <pc:sldMk cId="1085601703" sldId="259"/>
            <ac:spMk id="4" creationId="{0EB0D4D0-889A-9014-B30B-2E655B58E30F}"/>
          </ac:spMkLst>
        </pc:spChg>
        <pc:picChg chg="add mod">
          <ac:chgData name="Aravind Gandhi" userId="20e1d1d5cf36f95c" providerId="LiveId" clId="{80F8DC1F-0DA5-4331-8DAB-E46B6D0B748B}" dt="2023-07-18T17:07:06.936" v="87" actId="14100"/>
          <ac:picMkLst>
            <pc:docMk/>
            <pc:sldMk cId="1085601703" sldId="259"/>
            <ac:picMk id="3" creationId="{97A04C13-B64B-EF85-1A62-B7827A4C5ACD}"/>
          </ac:picMkLst>
        </pc:picChg>
      </pc:sldChg>
      <pc:sldChg chg="addSp modSp add mod">
        <pc:chgData name="Aravind Gandhi" userId="20e1d1d5cf36f95c" providerId="LiveId" clId="{80F8DC1F-0DA5-4331-8DAB-E46B6D0B748B}" dt="2023-07-18T17:48:59.077" v="213" actId="20577"/>
        <pc:sldMkLst>
          <pc:docMk/>
          <pc:sldMk cId="1579902890" sldId="260"/>
        </pc:sldMkLst>
        <pc:spChg chg="add mod">
          <ac:chgData name="Aravind Gandhi" userId="20e1d1d5cf36f95c" providerId="LiveId" clId="{80F8DC1F-0DA5-4331-8DAB-E46B6D0B748B}" dt="2023-07-18T17:48:59.077" v="213" actId="20577"/>
          <ac:spMkLst>
            <pc:docMk/>
            <pc:sldMk cId="1579902890" sldId="260"/>
            <ac:spMk id="4" creationId="{3A566043-659D-81A1-7A1E-7193E1D308AA}"/>
          </ac:spMkLst>
        </pc:spChg>
        <pc:picChg chg="add mod">
          <ac:chgData name="Aravind Gandhi" userId="20e1d1d5cf36f95c" providerId="LiveId" clId="{80F8DC1F-0DA5-4331-8DAB-E46B6D0B748B}" dt="2023-07-18T17:18:50.950" v="181" actId="1076"/>
          <ac:picMkLst>
            <pc:docMk/>
            <pc:sldMk cId="1579902890" sldId="260"/>
            <ac:picMk id="3" creationId="{95521E99-47B5-FE98-10B9-345161474D77}"/>
          </ac:picMkLst>
        </pc:picChg>
      </pc:sldChg>
      <pc:sldChg chg="addSp modSp add mod">
        <pc:chgData name="Aravind Gandhi" userId="20e1d1d5cf36f95c" providerId="LiveId" clId="{80F8DC1F-0DA5-4331-8DAB-E46B6D0B748B}" dt="2023-07-18T17:49:34.439" v="243" actId="20577"/>
        <pc:sldMkLst>
          <pc:docMk/>
          <pc:sldMk cId="491368906" sldId="261"/>
        </pc:sldMkLst>
        <pc:spChg chg="add mod">
          <ac:chgData name="Aravind Gandhi" userId="20e1d1d5cf36f95c" providerId="LiveId" clId="{80F8DC1F-0DA5-4331-8DAB-E46B6D0B748B}" dt="2023-07-18T17:49:34.439" v="243" actId="20577"/>
          <ac:spMkLst>
            <pc:docMk/>
            <pc:sldMk cId="491368906" sldId="261"/>
            <ac:spMk id="4" creationId="{2B6734EE-D2EB-33FD-4520-90F3044DDAE2}"/>
          </ac:spMkLst>
        </pc:spChg>
        <pc:picChg chg="add mod">
          <ac:chgData name="Aravind Gandhi" userId="20e1d1d5cf36f95c" providerId="LiveId" clId="{80F8DC1F-0DA5-4331-8DAB-E46B6D0B748B}" dt="2023-07-18T17:49:09.141" v="216" actId="1076"/>
          <ac:picMkLst>
            <pc:docMk/>
            <pc:sldMk cId="491368906" sldId="261"/>
            <ac:picMk id="3" creationId="{B9E5057D-04B9-9903-D52C-DC3650E041AF}"/>
          </ac:picMkLst>
        </pc:picChg>
      </pc:sldChg>
      <pc:sldChg chg="addSp modSp add mod ord">
        <pc:chgData name="Aravind Gandhi" userId="20e1d1d5cf36f95c" providerId="LiveId" clId="{80F8DC1F-0DA5-4331-8DAB-E46B6D0B748B}" dt="2023-07-18T18:02:26.845" v="386"/>
        <pc:sldMkLst>
          <pc:docMk/>
          <pc:sldMk cId="3518658403" sldId="262"/>
        </pc:sldMkLst>
        <pc:spChg chg="add mod">
          <ac:chgData name="Aravind Gandhi" userId="20e1d1d5cf36f95c" providerId="LiveId" clId="{80F8DC1F-0DA5-4331-8DAB-E46B6D0B748B}" dt="2023-07-18T17:51:25.686" v="302" actId="20577"/>
          <ac:spMkLst>
            <pc:docMk/>
            <pc:sldMk cId="3518658403" sldId="262"/>
            <ac:spMk id="4" creationId="{087204C2-D0F6-C2A4-00DE-787A59AA276A}"/>
          </ac:spMkLst>
        </pc:spChg>
        <pc:picChg chg="add mod">
          <ac:chgData name="Aravind Gandhi" userId="20e1d1d5cf36f95c" providerId="LiveId" clId="{80F8DC1F-0DA5-4331-8DAB-E46B6D0B748B}" dt="2023-07-18T17:49:20.388" v="221" actId="1076"/>
          <ac:picMkLst>
            <pc:docMk/>
            <pc:sldMk cId="3518658403" sldId="262"/>
            <ac:picMk id="3" creationId="{17DA8426-CE58-2DC7-3237-7BEA3D8BAFCF}"/>
          </ac:picMkLst>
        </pc:picChg>
      </pc:sldChg>
      <pc:sldChg chg="add del">
        <pc:chgData name="Aravind Gandhi" userId="20e1d1d5cf36f95c" providerId="LiveId" clId="{80F8DC1F-0DA5-4331-8DAB-E46B6D0B748B}" dt="2023-07-18T17:21:31.093" v="190" actId="47"/>
        <pc:sldMkLst>
          <pc:docMk/>
          <pc:sldMk cId="1164847088" sldId="263"/>
        </pc:sldMkLst>
      </pc:sldChg>
      <pc:sldChg chg="addSp modSp add mod ord">
        <pc:chgData name="Aravind Gandhi" userId="20e1d1d5cf36f95c" providerId="LiveId" clId="{80F8DC1F-0DA5-4331-8DAB-E46B6D0B748B}" dt="2023-07-18T17:53:57.831" v="381"/>
        <pc:sldMkLst>
          <pc:docMk/>
          <pc:sldMk cId="1307711871" sldId="264"/>
        </pc:sldMkLst>
        <pc:spChg chg="add mod">
          <ac:chgData name="Aravind Gandhi" userId="20e1d1d5cf36f95c" providerId="LiveId" clId="{80F8DC1F-0DA5-4331-8DAB-E46B6D0B748B}" dt="2023-07-18T17:53:57.831" v="381"/>
          <ac:spMkLst>
            <pc:docMk/>
            <pc:sldMk cId="1307711871" sldId="264"/>
            <ac:spMk id="4" creationId="{9FD112CD-8F96-072F-CAD0-1556FDF93684}"/>
          </ac:spMkLst>
        </pc:spChg>
        <pc:picChg chg="add mod">
          <ac:chgData name="Aravind Gandhi" userId="20e1d1d5cf36f95c" providerId="LiveId" clId="{80F8DC1F-0DA5-4331-8DAB-E46B6D0B748B}" dt="2023-07-18T17:16:46.658" v="156"/>
          <ac:picMkLst>
            <pc:docMk/>
            <pc:sldMk cId="1307711871" sldId="264"/>
            <ac:picMk id="3" creationId="{51E755BB-0E8B-5633-BB50-10702CB54E66}"/>
          </ac:picMkLst>
        </pc:picChg>
      </pc:sldChg>
      <pc:sldChg chg="addSp delSp modSp add mod">
        <pc:chgData name="Aravind Gandhi" userId="20e1d1d5cf36f95c" providerId="LiveId" clId="{80F8DC1F-0DA5-4331-8DAB-E46B6D0B748B}" dt="2023-07-18T17:53:41.556" v="378" actId="20577"/>
        <pc:sldMkLst>
          <pc:docMk/>
          <pc:sldMk cId="566509050" sldId="265"/>
        </pc:sldMkLst>
        <pc:spChg chg="add del mod">
          <ac:chgData name="Aravind Gandhi" userId="20e1d1d5cf36f95c" providerId="LiveId" clId="{80F8DC1F-0DA5-4331-8DAB-E46B6D0B748B}" dt="2023-07-18T17:17:37.931" v="163"/>
          <ac:spMkLst>
            <pc:docMk/>
            <pc:sldMk cId="566509050" sldId="265"/>
            <ac:spMk id="4" creationId="{E041B19D-FC67-B155-2D49-AE82CD5A720A}"/>
          </ac:spMkLst>
        </pc:spChg>
        <pc:spChg chg="add mod">
          <ac:chgData name="Aravind Gandhi" userId="20e1d1d5cf36f95c" providerId="LiveId" clId="{80F8DC1F-0DA5-4331-8DAB-E46B6D0B748B}" dt="2023-07-18T17:53:41.556" v="378" actId="20577"/>
          <ac:spMkLst>
            <pc:docMk/>
            <pc:sldMk cId="566509050" sldId="265"/>
            <ac:spMk id="5" creationId="{236C1D71-7042-995B-8F22-064C6D36A086}"/>
          </ac:spMkLst>
        </pc:spChg>
        <pc:picChg chg="add mod">
          <ac:chgData name="Aravind Gandhi" userId="20e1d1d5cf36f95c" providerId="LiveId" clId="{80F8DC1F-0DA5-4331-8DAB-E46B6D0B748B}" dt="2023-07-18T17:16:58.817" v="158"/>
          <ac:picMkLst>
            <pc:docMk/>
            <pc:sldMk cId="566509050" sldId="265"/>
            <ac:picMk id="3" creationId="{BFF27359-6DDB-46CB-283A-08DDD4882D13}"/>
          </ac:picMkLst>
        </pc:picChg>
      </pc:sldChg>
      <pc:sldChg chg="addSp delSp modSp add del mod">
        <pc:chgData name="Aravind Gandhi" userId="20e1d1d5cf36f95c" providerId="LiveId" clId="{80F8DC1F-0DA5-4331-8DAB-E46B6D0B748B}" dt="2023-07-18T17:48:32.588" v="200" actId="47"/>
        <pc:sldMkLst>
          <pc:docMk/>
          <pc:sldMk cId="1517977766" sldId="266"/>
        </pc:sldMkLst>
        <pc:picChg chg="del">
          <ac:chgData name="Aravind Gandhi" userId="20e1d1d5cf36f95c" providerId="LiveId" clId="{80F8DC1F-0DA5-4331-8DAB-E46B6D0B748B}" dt="2023-07-18T17:45:33.355" v="192" actId="478"/>
          <ac:picMkLst>
            <pc:docMk/>
            <pc:sldMk cId="1517977766" sldId="266"/>
            <ac:picMk id="3" creationId="{B9E5057D-04B9-9903-D52C-DC3650E041AF}"/>
          </ac:picMkLst>
        </pc:picChg>
        <pc:picChg chg="add mod">
          <ac:chgData name="Aravind Gandhi" userId="20e1d1d5cf36f95c" providerId="LiveId" clId="{80F8DC1F-0DA5-4331-8DAB-E46B6D0B748B}" dt="2023-07-18T17:46:09.852" v="193"/>
          <ac:picMkLst>
            <pc:docMk/>
            <pc:sldMk cId="1517977766" sldId="266"/>
            <ac:picMk id="4" creationId="{F16C1488-5779-C1B8-9EF6-71D3C6703A11}"/>
          </ac:picMkLst>
        </pc:picChg>
      </pc:sldChg>
      <pc:sldChg chg="addSp delSp modSp add del mod">
        <pc:chgData name="Aravind Gandhi" userId="20e1d1d5cf36f95c" providerId="LiveId" clId="{80F8DC1F-0DA5-4331-8DAB-E46B6D0B748B}" dt="2023-07-18T17:48:31.998" v="199" actId="47"/>
        <pc:sldMkLst>
          <pc:docMk/>
          <pc:sldMk cId="2313515139" sldId="267"/>
        </pc:sldMkLst>
        <pc:picChg chg="add mod">
          <ac:chgData name="Aravind Gandhi" userId="20e1d1d5cf36f95c" providerId="LiveId" clId="{80F8DC1F-0DA5-4331-8DAB-E46B6D0B748B}" dt="2023-07-18T17:46:49.118" v="198"/>
          <ac:picMkLst>
            <pc:docMk/>
            <pc:sldMk cId="2313515139" sldId="267"/>
            <ac:picMk id="3" creationId="{4FE7C23E-3328-DEAE-5F4D-D083936BE586}"/>
          </ac:picMkLst>
        </pc:picChg>
        <pc:picChg chg="del mod">
          <ac:chgData name="Aravind Gandhi" userId="20e1d1d5cf36f95c" providerId="LiveId" clId="{80F8DC1F-0DA5-4331-8DAB-E46B6D0B748B}" dt="2023-07-18T17:46:37.615" v="197" actId="478"/>
          <ac:picMkLst>
            <pc:docMk/>
            <pc:sldMk cId="2313515139" sldId="267"/>
            <ac:picMk id="4" creationId="{F16C1488-5779-C1B8-9EF6-71D3C6703A11}"/>
          </ac:picMkLst>
        </pc:picChg>
      </pc:sldChg>
      <pc:sldMasterChg chg="addSldLayout modSldLayout">
        <pc:chgData name="Aravind Gandhi" userId="20e1d1d5cf36f95c" providerId="LiveId" clId="{80F8DC1F-0DA5-4331-8DAB-E46B6D0B748B}" dt="2023-07-18T17:04:25.116" v="19"/>
        <pc:sldMasterMkLst>
          <pc:docMk/>
          <pc:sldMasterMk cId="3365155069" sldId="2147483648"/>
        </pc:sldMasterMkLst>
        <pc:sldLayoutChg chg="modSp add">
          <pc:chgData name="Aravind Gandhi" userId="20e1d1d5cf36f95c" providerId="LiveId" clId="{80F8DC1F-0DA5-4331-8DAB-E46B6D0B748B}" dt="2023-07-18T17:04:25.116" v="19"/>
          <pc:sldLayoutMkLst>
            <pc:docMk/>
            <pc:sldMasterMk cId="3365155069" sldId="2147483648"/>
            <pc:sldLayoutMk cId="3573268963" sldId="2147483649"/>
          </pc:sldLayoutMkLst>
          <pc:spChg chg="mod">
            <ac:chgData name="Aravind Gandhi" userId="20e1d1d5cf36f95c" providerId="LiveId" clId="{80F8DC1F-0DA5-4331-8DAB-E46B6D0B748B}" dt="2023-07-18T17:04:25.116" v="19"/>
            <ac:spMkLst>
              <pc:docMk/>
              <pc:sldMasterMk cId="3365155069" sldId="2147483648"/>
              <pc:sldLayoutMk cId="3573268963" sldId="2147483649"/>
              <ac:spMk id="2" creationId="{DBBD6D66-B3CF-BB86-BFA4-D4520E5BB45E}"/>
            </ac:spMkLst>
          </pc:spChg>
          <pc:spChg chg="mod">
            <ac:chgData name="Aravind Gandhi" userId="20e1d1d5cf36f95c" providerId="LiveId" clId="{80F8DC1F-0DA5-4331-8DAB-E46B6D0B748B}" dt="2023-07-18T17:04:25.116" v="19"/>
            <ac:spMkLst>
              <pc:docMk/>
              <pc:sldMasterMk cId="3365155069" sldId="2147483648"/>
              <pc:sldLayoutMk cId="3573268963" sldId="2147483649"/>
              <ac:spMk id="3" creationId="{0F0CCC26-89C2-0BDD-3478-51B56B7EB1B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073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5785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732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364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8634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2164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92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1081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3710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106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3189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7/1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0766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FF27359-6DDB-46CB-283A-08DDD4882D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50" y="0"/>
            <a:ext cx="857250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36C1D71-7042-995B-8F22-064C6D36A086}"/>
              </a:ext>
            </a:extLst>
          </p:cNvPr>
          <p:cNvSpPr txBox="1"/>
          <p:nvPr/>
        </p:nvSpPr>
        <p:spPr>
          <a:xfrm>
            <a:off x="999744" y="280416"/>
            <a:ext cx="73395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Doi Plot of pooled prevalence of HIV among individuals with </a:t>
            </a:r>
            <a:r>
              <a:rPr lang="en-IN" sz="15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pox</a:t>
            </a:r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566509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1E755BB-0E8B-5633-BB50-10702CB54E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50" y="0"/>
            <a:ext cx="857250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FD112CD-8F96-072F-CAD0-1556FDF93684}"/>
              </a:ext>
            </a:extLst>
          </p:cNvPr>
          <p:cNvSpPr txBox="1"/>
          <p:nvPr/>
        </p:nvSpPr>
        <p:spPr>
          <a:xfrm>
            <a:off x="902208" y="182880"/>
            <a:ext cx="733958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Funnel plot with 95% Confidence interval of pooled prevalence of HIV among individuals with </a:t>
            </a:r>
            <a:r>
              <a:rPr lang="en-IN" sz="15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pox</a:t>
            </a:r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13077118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521E99-47B5-FE98-10B9-345161474D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161582"/>
            <a:ext cx="533400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A566043-659D-81A1-7A1E-7193E1D308AA}"/>
              </a:ext>
            </a:extLst>
          </p:cNvPr>
          <p:cNvSpPr txBox="1"/>
          <p:nvPr/>
        </p:nvSpPr>
        <p:spPr>
          <a:xfrm>
            <a:off x="2049639" y="0"/>
            <a:ext cx="73395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Forest</a:t>
            </a:r>
            <a:r>
              <a:rPr lang="en-IN" sz="15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 of the sub-group analysis according to place of the study</a:t>
            </a:r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1579902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E5057D-04B9-9903-D52C-DC3650E041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108" y="386499"/>
            <a:ext cx="7450710" cy="63863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B6734EE-D2EB-33FD-4520-90F3044DDAE2}"/>
              </a:ext>
            </a:extLst>
          </p:cNvPr>
          <p:cNvSpPr txBox="1"/>
          <p:nvPr/>
        </p:nvSpPr>
        <p:spPr>
          <a:xfrm>
            <a:off x="1540591" y="85178"/>
            <a:ext cx="73395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Forest</a:t>
            </a:r>
            <a:r>
              <a:rPr lang="en-IN" sz="15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 of the sub-group analysis according to period of study</a:t>
            </a:r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4913689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7DA8426-CE58-2DC7-3237-7BEA3D8BAF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207390"/>
            <a:ext cx="6400799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87204C2-D0F6-C2A4-00DE-787A59AA276A}"/>
              </a:ext>
            </a:extLst>
          </p:cNvPr>
          <p:cNvSpPr txBox="1"/>
          <p:nvPr/>
        </p:nvSpPr>
        <p:spPr>
          <a:xfrm>
            <a:off x="1540591" y="85178"/>
            <a:ext cx="73395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 Forest</a:t>
            </a:r>
            <a:r>
              <a:rPr lang="en-IN" sz="15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5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 of the sub-group analysis according to endemicity of </a:t>
            </a:r>
            <a:r>
              <a:rPr lang="en-IN" sz="15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pox</a:t>
            </a:r>
            <a:endParaRPr lang="en-IN" sz="1500" dirty="0"/>
          </a:p>
        </p:txBody>
      </p:sp>
    </p:spTree>
    <p:extLst>
      <p:ext uri="{BB962C8B-B14F-4D97-AF65-F5344CB8AC3E}">
        <p14:creationId xmlns:p14="http://schemas.microsoft.com/office/powerpoint/2010/main" val="35186584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A40D73F-A6BE-CD4F-D9D0-30C750E781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96" y="865197"/>
            <a:ext cx="8569235" cy="53557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BB33867-304F-6D95-6DBB-19237542D362}"/>
              </a:ext>
            </a:extLst>
          </p:cNvPr>
          <p:cNvSpPr txBox="1"/>
          <p:nvPr/>
        </p:nvSpPr>
        <p:spPr>
          <a:xfrm>
            <a:off x="6360956" y="676221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eta=-0.006, p=0.44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28AD51F-EE47-881A-E293-337AFD6F17F7}"/>
              </a:ext>
            </a:extLst>
          </p:cNvPr>
          <p:cNvSpPr txBox="1"/>
          <p:nvPr/>
        </p:nvSpPr>
        <p:spPr>
          <a:xfrm>
            <a:off x="703870" y="1059834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6:</a:t>
            </a:r>
          </a:p>
        </p:txBody>
      </p:sp>
    </p:spTree>
    <p:extLst>
      <p:ext uri="{BB962C8B-B14F-4D97-AF65-F5344CB8AC3E}">
        <p14:creationId xmlns:p14="http://schemas.microsoft.com/office/powerpoint/2010/main" val="31986585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C1EA82E-8E83-E4CF-40DE-66CE6D75B0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479" y="833628"/>
            <a:ext cx="8557042" cy="53481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B4E96DB-B79C-C2F1-1D05-129A038267D2}"/>
              </a:ext>
            </a:extLst>
          </p:cNvPr>
          <p:cNvSpPr txBox="1"/>
          <p:nvPr/>
        </p:nvSpPr>
        <p:spPr>
          <a:xfrm>
            <a:off x="6314585" y="644652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eta=0.007, p=0.18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7089EF-6EF0-6712-35AA-FBB57635D6F9}"/>
              </a:ext>
            </a:extLst>
          </p:cNvPr>
          <p:cNvSpPr txBox="1"/>
          <p:nvPr/>
        </p:nvSpPr>
        <p:spPr>
          <a:xfrm>
            <a:off x="122792" y="1022604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7: </a:t>
            </a:r>
          </a:p>
        </p:txBody>
      </p:sp>
    </p:spTree>
    <p:extLst>
      <p:ext uri="{BB962C8B-B14F-4D97-AF65-F5344CB8AC3E}">
        <p14:creationId xmlns:p14="http://schemas.microsoft.com/office/powerpoint/2010/main" val="29304281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A04C13-B64B-EF85-1A62-B7827A4C5A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1" y="816428"/>
            <a:ext cx="8569234" cy="53557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EB0D4D0-889A-9014-B30B-2E655B58E30F}"/>
              </a:ext>
            </a:extLst>
          </p:cNvPr>
          <p:cNvSpPr txBox="1"/>
          <p:nvPr/>
        </p:nvSpPr>
        <p:spPr>
          <a:xfrm>
            <a:off x="6512916" y="627452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eta&lt;-0.001, p=0.91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24354E-6126-2E7F-77C1-C45430FC4119}"/>
              </a:ext>
            </a:extLst>
          </p:cNvPr>
          <p:cNvSpPr txBox="1"/>
          <p:nvPr/>
        </p:nvSpPr>
        <p:spPr>
          <a:xfrm>
            <a:off x="598280" y="998872"/>
            <a:ext cx="2535936" cy="377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8: </a:t>
            </a:r>
          </a:p>
        </p:txBody>
      </p:sp>
    </p:spTree>
    <p:extLst>
      <p:ext uri="{BB962C8B-B14F-4D97-AF65-F5344CB8AC3E}">
        <p14:creationId xmlns:p14="http://schemas.microsoft.com/office/powerpoint/2010/main" val="678304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2</TotalTime>
  <Words>108</Words>
  <Application>Microsoft Office PowerPoint</Application>
  <PresentationFormat>On-screen Show (4:3)</PresentationFormat>
  <Paragraphs>1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</dc:creator>
  <cp:lastModifiedBy>Aravind</cp:lastModifiedBy>
  <cp:revision>1</cp:revision>
  <dcterms:created xsi:type="dcterms:W3CDTF">2023-07-18T17:00:47Z</dcterms:created>
  <dcterms:modified xsi:type="dcterms:W3CDTF">2023-07-18T18:04:47Z</dcterms:modified>
</cp:coreProperties>
</file>